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76A354-6160-4AD8-AB08-1553EDA6029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0A8D2C-01D1-4D9F-99DC-46CFD5F32B7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AFCCD-5BA0-4BAD-BFDB-61EBD91B48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AE5F2-0316-4AD3-AE8E-A532B5CA10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9DA20-C866-4B06-9966-FC411812F2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9B6D2-BD80-4726-B154-5433B0A2F0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D3C93-2198-44D2-99FA-74207F5D15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76E1A-8C98-4065-904A-FFBB1C10EF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FB817-1F8A-43EE-8C9D-95E4FBB767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23832-1E0D-4539-8940-2929F9181F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0D67C-97AB-4ADF-8F8C-727117BAAC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7958A-8BB8-416E-897D-CE39A1C465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03DA0-B222-44C5-B6BD-86726A226E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2131C-4F3E-4449-B140-A6892A5CBA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D5E935-72BC-4B7A-BA32-0A46ECB49D9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685800" y="2587680"/>
            <a:ext cx="7837560" cy="244152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1203120" y="947880"/>
            <a:ext cx="6471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6 Wheat LKR/SDH EST contig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heat ESTs containing LKR/SDH sequences were assembled into three contigs and compared to the BA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KR/SDH coding and 3’-UTR sequence. Genome assignments are indicated by A, B, and D labels on branche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mber of ESTs within each contig is given in parenthes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20:49:59Z</dcterms:created>
  <dc:creator> </dc:creator>
  <dc:description/>
  <dc:language>en-US</dc:language>
  <cp:lastModifiedBy>Office 2003 Registered User</cp:lastModifiedBy>
  <dcterms:modified xsi:type="dcterms:W3CDTF">2010-05-18T22:40:40Z</dcterms:modified>
  <cp:revision>2</cp:revision>
  <dc:subject/>
  <dc:title>Slide 1</dc:title>
</cp:coreProperties>
</file>